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4" d="100"/>
          <a:sy n="104" d="100"/>
        </p:scale>
        <p:origin x="120" y="9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14/03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4/03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4/03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4/03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4/03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4/03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4/03/2022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4/03/2022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4/03/2022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4/03/2022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4/03/2022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4/03/2022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14/03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32552" y="5749338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Ling (2022) Diabetologia DOI 10.1007/s00125-022-05681-x </a:t>
            </a:r>
          </a:p>
          <a:p>
            <a:r>
              <a:rPr lang="en-GB" sz="1200" dirty="0"/>
              <a:t>©The Author(s) 2022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err="1"/>
              <a:t>Pharmacoepigenetics</a:t>
            </a:r>
            <a:r>
              <a:rPr lang="en-GB" sz="2000" b="1" dirty="0"/>
              <a:t> in type 2 diabetes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8D4F5813-2F20-47F4-8B57-83E21B7D631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171449" y="764704"/>
            <a:ext cx="5017126" cy="50131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5</TotalTime>
  <Words>47</Words>
  <Application>Microsoft Office PowerPoint</Application>
  <PresentationFormat>On-screen Show (4:3)</PresentationFormat>
  <Paragraphs>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Madeleine Stimpson</cp:lastModifiedBy>
  <cp:revision>39</cp:revision>
  <dcterms:created xsi:type="dcterms:W3CDTF">2016-06-15T12:53:43Z</dcterms:created>
  <dcterms:modified xsi:type="dcterms:W3CDTF">2022-03-14T11:23:59Z</dcterms:modified>
</cp:coreProperties>
</file>